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drawings/drawing1.xml" ContentType="application/vnd.openxmlformats-officedocument.drawingml.chartshapes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7613" autoAdjust="0"/>
  </p:normalViewPr>
  <p:slideViewPr>
    <p:cSldViewPr snapToGrid="0" snapToObjects="1">
      <p:cViewPr>
        <p:scale>
          <a:sx n="72" d="100"/>
          <a:sy n="72" d="100"/>
        </p:scale>
        <p:origin x="-1416" y="4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Relationship Id="rId2" Type="http://schemas.openxmlformats.org/officeDocument/2006/relationships/chartUserShapes" Target="../drawings/drawing1.xm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3470;&#26412;%20&#12354;&#12377;&#12363;\Desktop\IL4%20&#32048;&#32990;&#25968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3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5AA5-4087-9D03-B8EFCD307C30}"/>
              </c:ext>
            </c:extLst>
          </c:dPt>
          <c:dPt>
            <c:idx val="20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5AA5-4087-9D03-B8EFCD307C30}"/>
              </c:ext>
            </c:extLst>
          </c:dPt>
          <c:dLbls>
            <c:dLbl>
              <c:idx val="3"/>
              <c:layout>
                <c:manualLayout>
                  <c:x val="-0.142874748680509"/>
                  <c:y val="0.039148453270484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46228578005292226"/>
                      <c:h val="0.1137333234692116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5AA5-4087-9D03-B8EFCD307C30}"/>
                </c:ext>
              </c:extLst>
            </c:dLbl>
            <c:dLbl>
              <c:idx val="20"/>
              <c:layout>
                <c:manualLayout>
                  <c:x val="-0.195203184296886"/>
                  <c:y val="-0.0780419366089263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46343161359844698"/>
                      <c:h val="0.1437299414846207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5AA5-4087-9D03-B8EFCD307C3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Q$4:$Q$24</c:f>
              <c:numCache>
                <c:formatCode>General</c:formatCode>
                <c:ptCount val="21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  <c:pt idx="15">
                  <c:v>1.5</c:v>
                </c:pt>
                <c:pt idx="16">
                  <c:v>1.5</c:v>
                </c:pt>
                <c:pt idx="17">
                  <c:v>1.5</c:v>
                </c:pt>
                <c:pt idx="18">
                  <c:v>1.5</c:v>
                </c:pt>
                <c:pt idx="19">
                  <c:v>1.5</c:v>
                </c:pt>
                <c:pt idx="20">
                  <c:v>1.5</c:v>
                </c:pt>
              </c:numCache>
            </c:numRef>
          </c:xVal>
          <c:yVal>
            <c:numRef>
              <c:f>まとめ!$N$4:$N$24</c:f>
              <c:numCache>
                <c:formatCode>0.00E+00</c:formatCode>
                <c:ptCount val="21"/>
                <c:pt idx="0">
                  <c:v>1.3E8</c:v>
                </c:pt>
                <c:pt idx="1">
                  <c:v>6.3E7</c:v>
                </c:pt>
                <c:pt idx="2">
                  <c:v>3.5E6</c:v>
                </c:pt>
                <c:pt idx="3">
                  <c:v>6.55E7</c:v>
                </c:pt>
                <c:pt idx="5">
                  <c:v>2.3E8</c:v>
                </c:pt>
                <c:pt idx="6">
                  <c:v>6.2E7</c:v>
                </c:pt>
                <c:pt idx="7">
                  <c:v>5.0E7</c:v>
                </c:pt>
                <c:pt idx="8">
                  <c:v>6.8E7</c:v>
                </c:pt>
                <c:pt idx="9">
                  <c:v>1.2E8</c:v>
                </c:pt>
                <c:pt idx="10">
                  <c:v>3.6E7</c:v>
                </c:pt>
                <c:pt idx="11">
                  <c:v>1.3E7</c:v>
                </c:pt>
                <c:pt idx="12">
                  <c:v>3.3E7</c:v>
                </c:pt>
                <c:pt idx="13">
                  <c:v>2.8E8</c:v>
                </c:pt>
                <c:pt idx="14">
                  <c:v>7.3E7</c:v>
                </c:pt>
                <c:pt idx="15">
                  <c:v>1.1E8</c:v>
                </c:pt>
                <c:pt idx="16">
                  <c:v>2.0E7</c:v>
                </c:pt>
                <c:pt idx="17">
                  <c:v>1.8E8</c:v>
                </c:pt>
                <c:pt idx="18">
                  <c:v>1.2E8</c:v>
                </c:pt>
                <c:pt idx="19">
                  <c:v>2.3E7</c:v>
                </c:pt>
                <c:pt idx="20">
                  <c:v>9.45333333333333E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5AA5-4087-9D03-B8EFCD307C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0129368"/>
        <c:axId val="-2070128584"/>
      </c:scatterChart>
      <c:valAx>
        <c:axId val="-2070129368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070128584"/>
        <c:crosses val="autoZero"/>
        <c:crossBetween val="midCat"/>
        <c:majorUnit val="0.5"/>
      </c:valAx>
      <c:valAx>
        <c:axId val="-2070128584"/>
        <c:scaling>
          <c:orientation val="minMax"/>
          <c:max val="6.0E8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E+00" sourceLinked="1"/>
        <c:majorTickMark val="out"/>
        <c:minorTickMark val="none"/>
        <c:tickLblPos val="nextTo"/>
        <c:crossAx val="-2070129368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3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8B8E-407B-B731-4E3987BB76CB}"/>
              </c:ext>
            </c:extLst>
          </c:dPt>
          <c:dPt>
            <c:idx val="14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8B8E-407B-B731-4E3987BB76CB}"/>
              </c:ext>
            </c:extLst>
          </c:dPt>
          <c:dLbls>
            <c:dLbl>
              <c:idx val="3"/>
              <c:layout>
                <c:manualLayout>
                  <c:x val="-0.103481500644722"/>
                  <c:y val="0.027963035949014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41308521538615101"/>
                      <c:h val="0.16699525068751639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8B8E-407B-B731-4E3987BB76CB}"/>
                </c:ext>
              </c:extLst>
            </c:dLbl>
            <c:dLbl>
              <c:idx val="14"/>
              <c:layout>
                <c:manualLayout>
                  <c:x val="-0.245768564031216"/>
                  <c:y val="-0.0419445539235222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40198845407193595"/>
                      <c:h val="0.1222543931690927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8B8E-407B-B731-4E3987BB76C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Z$4:$Z$18</c:f>
              <c:numCache>
                <c:formatCode>General</c:formatCode>
                <c:ptCount val="15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</c:numCache>
            </c:numRef>
          </c:xVal>
          <c:yVal>
            <c:numRef>
              <c:f>まとめ!$W$4:$W$18</c:f>
              <c:numCache>
                <c:formatCode>0.00E+00</c:formatCode>
                <c:ptCount val="15"/>
                <c:pt idx="0">
                  <c:v>9.5E7</c:v>
                </c:pt>
                <c:pt idx="1">
                  <c:v>2.9E7</c:v>
                </c:pt>
                <c:pt idx="2">
                  <c:v>1.3E6</c:v>
                </c:pt>
                <c:pt idx="3">
                  <c:v>4.17666666666667E7</c:v>
                </c:pt>
                <c:pt idx="5">
                  <c:v>2.3E8</c:v>
                </c:pt>
                <c:pt idx="6">
                  <c:v>1.2E8</c:v>
                </c:pt>
                <c:pt idx="7">
                  <c:v>1.0E8</c:v>
                </c:pt>
                <c:pt idx="8">
                  <c:v>1.8E8</c:v>
                </c:pt>
                <c:pt idx="9">
                  <c:v>1.3E8</c:v>
                </c:pt>
                <c:pt idx="10">
                  <c:v>4.5E7</c:v>
                </c:pt>
                <c:pt idx="11">
                  <c:v>1.1E8</c:v>
                </c:pt>
                <c:pt idx="12">
                  <c:v>5.3E7</c:v>
                </c:pt>
                <c:pt idx="13">
                  <c:v>1.0E8</c:v>
                </c:pt>
                <c:pt idx="14">
                  <c:v>1.18666666666667E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B8E-407B-B731-4E3987BB76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9139848"/>
        <c:axId val="-2143403416"/>
      </c:scatterChart>
      <c:valAx>
        <c:axId val="-2119139848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43403416"/>
        <c:crosses val="autoZero"/>
        <c:crossBetween val="midCat"/>
        <c:majorUnit val="0.5"/>
      </c:valAx>
      <c:valAx>
        <c:axId val="-2143403416"/>
        <c:scaling>
          <c:orientation val="minMax"/>
          <c:max val="6.0E8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E+00" sourceLinked="1"/>
        <c:majorTickMark val="out"/>
        <c:minorTickMark val="none"/>
        <c:tickLblPos val="nextTo"/>
        <c:crossAx val="-2119139848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6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AAE6-43F1-82CA-D0E164B88307}"/>
              </c:ext>
            </c:extLst>
          </c:dPt>
          <c:dPt>
            <c:idx val="11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AAE6-43F1-82CA-D0E164B88307}"/>
              </c:ext>
            </c:extLst>
          </c:dPt>
          <c:dLbls>
            <c:dLbl>
              <c:idx val="6"/>
              <c:layout>
                <c:manualLayout>
                  <c:x val="-0.0855218855218856"/>
                  <c:y val="-0.00559260718980296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37621590909090913"/>
                      <c:h val="0.1116843655803651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AAE6-43F1-82CA-D0E164B88307}"/>
                </c:ext>
              </c:extLst>
            </c:dLbl>
            <c:dLbl>
              <c:idx val="11"/>
              <c:layout>
                <c:manualLayout>
                  <c:x val="-0.0347432659932661"/>
                  <c:y val="-0.0559260718980296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29585311447811447"/>
                      <c:h val="0.18377307225692527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AAE6-43F1-82CA-D0E164B8830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AI$4:$AI$15</c:f>
              <c:numCache>
                <c:formatCode>General</c:formatCode>
                <c:ptCount val="12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</c:numCache>
            </c:numRef>
          </c:xVal>
          <c:yVal>
            <c:numRef>
              <c:f>まとめ!$AF$4:$AF$15</c:f>
              <c:numCache>
                <c:formatCode>0.00E+00</c:formatCode>
                <c:ptCount val="12"/>
                <c:pt idx="0">
                  <c:v>4.55E7</c:v>
                </c:pt>
                <c:pt idx="1">
                  <c:v>1.74E8</c:v>
                </c:pt>
                <c:pt idx="2">
                  <c:v>6.7E7</c:v>
                </c:pt>
                <c:pt idx="3">
                  <c:v>1.3E8</c:v>
                </c:pt>
                <c:pt idx="4">
                  <c:v>1.7E7</c:v>
                </c:pt>
                <c:pt idx="5">
                  <c:v>3.9E7</c:v>
                </c:pt>
                <c:pt idx="6">
                  <c:v>7.875E7</c:v>
                </c:pt>
                <c:pt idx="8">
                  <c:v>2.2E8</c:v>
                </c:pt>
                <c:pt idx="9">
                  <c:v>3.1E8</c:v>
                </c:pt>
                <c:pt idx="10">
                  <c:v>4.9E8</c:v>
                </c:pt>
                <c:pt idx="11">
                  <c:v>3.4E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AE6-43F1-82CA-D0E164B883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8732344"/>
        <c:axId val="-2098329992"/>
      </c:scatterChart>
      <c:valAx>
        <c:axId val="-2098732344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-2098329992"/>
        <c:crosses val="autoZero"/>
        <c:crossBetween val="midCat"/>
      </c:valAx>
      <c:valAx>
        <c:axId val="-2098329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09873234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3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AAAD-47FA-8A96-4EBC05BCAC68}"/>
              </c:ext>
            </c:extLst>
          </c:dPt>
          <c:dPt>
            <c:idx val="20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AAAD-47FA-8A96-4EBC05BCAC68}"/>
              </c:ext>
            </c:extLst>
          </c:dPt>
          <c:dLbls>
            <c:dLbl>
              <c:idx val="3"/>
              <c:layout>
                <c:manualLayout>
                  <c:x val="-0.0388055627417709"/>
                  <c:y val="0.0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AAAD-47FA-8A96-4EBC05BCAC68}"/>
                </c:ext>
              </c:extLst>
            </c:dLbl>
            <c:dLbl>
              <c:idx val="20"/>
              <c:layout>
                <c:manualLayout>
                  <c:x val="-0.0646759379029516"/>
                  <c:y val="-0.0447326235111323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20796064036308154"/>
                      <c:h val="0.1669645172553013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AAAD-47FA-8A96-4EBC05BCAC68}"/>
                </c:ext>
              </c:extLst>
            </c:dLbl>
            <c:numFmt formatCode="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Q$4:$Q$24</c:f>
              <c:numCache>
                <c:formatCode>General</c:formatCode>
                <c:ptCount val="21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  <c:pt idx="15">
                  <c:v>1.5</c:v>
                </c:pt>
                <c:pt idx="16">
                  <c:v>1.5</c:v>
                </c:pt>
                <c:pt idx="17">
                  <c:v>1.5</c:v>
                </c:pt>
                <c:pt idx="18">
                  <c:v>1.5</c:v>
                </c:pt>
                <c:pt idx="19">
                  <c:v>1.5</c:v>
                </c:pt>
                <c:pt idx="20">
                  <c:v>1.5</c:v>
                </c:pt>
              </c:numCache>
            </c:numRef>
          </c:xVal>
          <c:yVal>
            <c:numRef>
              <c:f>まとめ!$O$4:$O$24</c:f>
              <c:numCache>
                <c:formatCode>0.00</c:formatCode>
                <c:ptCount val="21"/>
                <c:pt idx="0">
                  <c:v>4.514999999999997</c:v>
                </c:pt>
                <c:pt idx="1">
                  <c:v>9.8814</c:v>
                </c:pt>
                <c:pt idx="2">
                  <c:v>2.421899999999999</c:v>
                </c:pt>
                <c:pt idx="3" formatCode="0.00E+00">
                  <c:v>5.6061</c:v>
                </c:pt>
                <c:pt idx="5">
                  <c:v>2.355839999999997</c:v>
                </c:pt>
                <c:pt idx="6">
                  <c:v>1.934939999999999</c:v>
                </c:pt>
                <c:pt idx="7">
                  <c:v>34.7319</c:v>
                </c:pt>
                <c:pt idx="8">
                  <c:v>18.55710000000001</c:v>
                </c:pt>
                <c:pt idx="9">
                  <c:v>20.276</c:v>
                </c:pt>
                <c:pt idx="10">
                  <c:v>17.0632</c:v>
                </c:pt>
                <c:pt idx="11">
                  <c:v>2.134259999999998</c:v>
                </c:pt>
                <c:pt idx="12">
                  <c:v>10.5078</c:v>
                </c:pt>
                <c:pt idx="13">
                  <c:v>1.55775</c:v>
                </c:pt>
                <c:pt idx="14">
                  <c:v>7.063680000000001</c:v>
                </c:pt>
                <c:pt idx="15">
                  <c:v>15.1514</c:v>
                </c:pt>
                <c:pt idx="16">
                  <c:v>1.134</c:v>
                </c:pt>
                <c:pt idx="17">
                  <c:v>1.439219999999999</c:v>
                </c:pt>
                <c:pt idx="18">
                  <c:v>19.07080000000001</c:v>
                </c:pt>
                <c:pt idx="19">
                  <c:v>1.36652</c:v>
                </c:pt>
                <c:pt idx="20" formatCode="0.00E+00">
                  <c:v>10.289627333333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AAD-47FA-8A96-4EBC05BCAC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99118616"/>
        <c:axId val="-2118519096"/>
      </c:scatterChart>
      <c:valAx>
        <c:axId val="-2099118616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18519096"/>
        <c:crosses val="autoZero"/>
        <c:crossBetween val="midCat"/>
        <c:majorUnit val="0.5"/>
      </c:valAx>
      <c:valAx>
        <c:axId val="-2118519096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crossAx val="-2099118616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3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D564-4242-8CD4-A30288472CD0}"/>
              </c:ext>
            </c:extLst>
          </c:dPt>
          <c:dPt>
            <c:idx val="14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D564-4242-8CD4-A30288472CD0}"/>
              </c:ext>
            </c:extLst>
          </c:dPt>
          <c:dLbls>
            <c:dLbl>
              <c:idx val="3"/>
              <c:layout>
                <c:manualLayout>
                  <c:x val="-0.0323379689514757"/>
                  <c:y val="-1.02511077996291E-16"/>
                </c:manualLayout>
              </c:layout>
              <c:numFmt formatCode="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D564-4242-8CD4-A30288472CD0}"/>
                </c:ext>
              </c:extLst>
            </c:dLbl>
            <c:dLbl>
              <c:idx val="14"/>
              <c:layout>
                <c:manualLayout>
                  <c:x val="-0.0646759379029515"/>
                  <c:y val="-0.0391410455722409"/>
                </c:manualLayout>
              </c:layout>
              <c:numFmt formatCode="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20796064036308154"/>
                      <c:h val="0.1669645172553013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D564-4242-8CD4-A30288472CD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Z$4:$Z$18</c:f>
              <c:numCache>
                <c:formatCode>General</c:formatCode>
                <c:ptCount val="15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</c:numCache>
            </c:numRef>
          </c:xVal>
          <c:yVal>
            <c:numRef>
              <c:f>まとめ!$X$4:$X$18</c:f>
              <c:numCache>
                <c:formatCode>0.00</c:formatCode>
                <c:ptCount val="15"/>
                <c:pt idx="0">
                  <c:v>6.9979</c:v>
                </c:pt>
                <c:pt idx="1">
                  <c:v>0.99792</c:v>
                </c:pt>
                <c:pt idx="2">
                  <c:v>1.19316</c:v>
                </c:pt>
                <c:pt idx="3" formatCode="0.00E+00">
                  <c:v>3.062993333333333</c:v>
                </c:pt>
                <c:pt idx="5">
                  <c:v>21.01120000000001</c:v>
                </c:pt>
                <c:pt idx="6">
                  <c:v>12.2122</c:v>
                </c:pt>
                <c:pt idx="7">
                  <c:v>15.4376</c:v>
                </c:pt>
                <c:pt idx="8">
                  <c:v>4.67523</c:v>
                </c:pt>
                <c:pt idx="9">
                  <c:v>3.913479999999998</c:v>
                </c:pt>
                <c:pt idx="10">
                  <c:v>14.0067</c:v>
                </c:pt>
                <c:pt idx="11">
                  <c:v>0.1839</c:v>
                </c:pt>
                <c:pt idx="12">
                  <c:v>19.32899999999999</c:v>
                </c:pt>
                <c:pt idx="13">
                  <c:v>5.24094</c:v>
                </c:pt>
                <c:pt idx="14" formatCode="0.00E+00">
                  <c:v>10.6678055555555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564-4242-8CD4-A30288472C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8494424"/>
        <c:axId val="-2119105400"/>
      </c:scatterChart>
      <c:valAx>
        <c:axId val="-2118494424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19105400"/>
        <c:crosses val="autoZero"/>
        <c:crossBetween val="midCat"/>
        <c:majorUnit val="0.5"/>
      </c:valAx>
      <c:valAx>
        <c:axId val="-2119105400"/>
        <c:scaling>
          <c:orientation val="minMax"/>
          <c:max val="40.0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crossAx val="-2118494424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6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7AC4-4CFC-8410-21054D01761B}"/>
              </c:ext>
            </c:extLst>
          </c:dPt>
          <c:dPt>
            <c:idx val="11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7AC4-4CFC-8410-21054D01761B}"/>
              </c:ext>
            </c:extLst>
          </c:dPt>
          <c:dLbls>
            <c:dLbl>
              <c:idx val="6"/>
              <c:layout>
                <c:manualLayout>
                  <c:x val="-0.0235185185185186"/>
                  <c:y val="0.0027960091103095"/>
                </c:manualLayout>
              </c:layout>
              <c:numFmt formatCode="0.0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14993055555555557"/>
                      <c:h val="9.7461203474879493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7AC4-4CFC-8410-21054D01761B}"/>
                </c:ext>
              </c:extLst>
            </c:dLbl>
            <c:dLbl>
              <c:idx val="11"/>
              <c:layout>
                <c:manualLayout>
                  <c:x val="-0.0411574074074075"/>
                  <c:y val="-1.02511077996291E-16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7AC4-4CFC-8410-21054D01761B}"/>
                </c:ext>
              </c:extLst>
            </c:dLbl>
            <c:numFmt formatCode="0.0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AI$4:$AI$15</c:f>
              <c:numCache>
                <c:formatCode>General</c:formatCode>
                <c:ptCount val="12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</c:numCache>
            </c:numRef>
          </c:xVal>
          <c:yVal>
            <c:numRef>
              <c:f>まとめ!$AG$4:$AG$15</c:f>
              <c:numCache>
                <c:formatCode>0.00</c:formatCode>
                <c:ptCount val="12"/>
                <c:pt idx="0">
                  <c:v>3.92886</c:v>
                </c:pt>
                <c:pt idx="1">
                  <c:v>1.80486</c:v>
                </c:pt>
                <c:pt idx="2">
                  <c:v>1.29656</c:v>
                </c:pt>
                <c:pt idx="3">
                  <c:v>12.1518</c:v>
                </c:pt>
                <c:pt idx="4">
                  <c:v>0.53067</c:v>
                </c:pt>
                <c:pt idx="5">
                  <c:v>0.422</c:v>
                </c:pt>
                <c:pt idx="6" formatCode="0.00E+00">
                  <c:v>3.355791666666667</c:v>
                </c:pt>
                <c:pt idx="8">
                  <c:v>2.08886</c:v>
                </c:pt>
                <c:pt idx="9">
                  <c:v>3.12044</c:v>
                </c:pt>
                <c:pt idx="10">
                  <c:v>1.88484</c:v>
                </c:pt>
                <c:pt idx="11" formatCode="0.00E+00">
                  <c:v>2.36471333333333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AC4-4CFC-8410-21054D0176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8497112"/>
        <c:axId val="-2114956856"/>
      </c:scatterChart>
      <c:valAx>
        <c:axId val="-2118497112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14956856"/>
        <c:crosses val="autoZero"/>
        <c:crossBetween val="midCat"/>
      </c:valAx>
      <c:valAx>
        <c:axId val="-2114956856"/>
        <c:scaling>
          <c:orientation val="minMax"/>
          <c:max val="4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-211849711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3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C618-406F-A49A-79E7503D5BCB}"/>
              </c:ext>
            </c:extLst>
          </c:dPt>
          <c:dPt>
            <c:idx val="20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C618-406F-A49A-79E7503D5BCB}"/>
              </c:ext>
            </c:extLst>
          </c:dPt>
          <c:dLbls>
            <c:dLbl>
              <c:idx val="3"/>
              <c:layout>
                <c:manualLayout>
                  <c:x val="-0.0905463130641321"/>
                  <c:y val="0.0279578896944576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36781205885408497"/>
                      <c:h val="0.18373925107197595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C618-406F-A49A-79E7503D5BCB}"/>
                </c:ext>
              </c:extLst>
            </c:dLbl>
            <c:dLbl>
              <c:idx val="20"/>
              <c:layout>
                <c:manualLayout>
                  <c:x val="-0.265171345402101"/>
                  <c:y val="-0.0419368345416865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36318289133016507"/>
                      <c:h val="0.1781476731330844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C618-406F-A49A-79E7503D5BC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Q$4:$Q$24</c:f>
              <c:numCache>
                <c:formatCode>General</c:formatCode>
                <c:ptCount val="21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  <c:pt idx="15">
                  <c:v>1.5</c:v>
                </c:pt>
                <c:pt idx="16">
                  <c:v>1.5</c:v>
                </c:pt>
                <c:pt idx="17">
                  <c:v>1.5</c:v>
                </c:pt>
                <c:pt idx="18">
                  <c:v>1.5</c:v>
                </c:pt>
                <c:pt idx="19">
                  <c:v>1.5</c:v>
                </c:pt>
                <c:pt idx="20">
                  <c:v>1.5</c:v>
                </c:pt>
              </c:numCache>
            </c:numRef>
          </c:xVal>
          <c:yVal>
            <c:numRef>
              <c:f>まとめ!$P$4:$P$24</c:f>
              <c:numCache>
                <c:formatCode>General</c:formatCode>
                <c:ptCount val="21"/>
                <c:pt idx="0">
                  <c:v>5.8695E6</c:v>
                </c:pt>
                <c:pt idx="1">
                  <c:v>6.225282E6</c:v>
                </c:pt>
                <c:pt idx="2">
                  <c:v>84766.49999999997</c:v>
                </c:pt>
                <c:pt idx="3" formatCode="0.00E+00">
                  <c:v>4.0598495E6</c:v>
                </c:pt>
                <c:pt idx="5">
                  <c:v>5.418432E6</c:v>
                </c:pt>
                <c:pt idx="6">
                  <c:v>1.1996628E6</c:v>
                </c:pt>
                <c:pt idx="7">
                  <c:v>1.736595E7</c:v>
                </c:pt>
                <c:pt idx="8">
                  <c:v>1.2618828E7</c:v>
                </c:pt>
                <c:pt idx="9">
                  <c:v>2.43312E7</c:v>
                </c:pt>
                <c:pt idx="10">
                  <c:v>6.142752E6</c:v>
                </c:pt>
                <c:pt idx="11">
                  <c:v>277453.8</c:v>
                </c:pt>
                <c:pt idx="12">
                  <c:v>3.467574E6</c:v>
                </c:pt>
                <c:pt idx="13">
                  <c:v>4.3617E6</c:v>
                </c:pt>
                <c:pt idx="14">
                  <c:v>5.1564864E6</c:v>
                </c:pt>
                <c:pt idx="15">
                  <c:v>1.666654E7</c:v>
                </c:pt>
                <c:pt idx="16">
                  <c:v>226799.9999999999</c:v>
                </c:pt>
                <c:pt idx="17">
                  <c:v>2.590596E6</c:v>
                </c:pt>
                <c:pt idx="18">
                  <c:v>2.288496E7</c:v>
                </c:pt>
                <c:pt idx="19">
                  <c:v>314299.6</c:v>
                </c:pt>
                <c:pt idx="20" formatCode="0.00E+00">
                  <c:v>8.20154897333333E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C618-406F-A49A-79E7503D5B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43610552"/>
        <c:axId val="-2143559560"/>
      </c:scatterChart>
      <c:valAx>
        <c:axId val="-2143610552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43559560"/>
        <c:crosses val="autoZero"/>
        <c:crossBetween val="midCat"/>
        <c:majorUnit val="0.5"/>
      </c:valAx>
      <c:valAx>
        <c:axId val="-2143559560"/>
        <c:scaling>
          <c:orientation val="minMax"/>
          <c:max val="6.0E7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crossAx val="-214361055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3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E297-4119-B69E-AA7F820D2378}"/>
              </c:ext>
            </c:extLst>
          </c:dPt>
          <c:dPt>
            <c:idx val="14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E297-4119-B69E-AA7F820D2378}"/>
              </c:ext>
            </c:extLst>
          </c:dPt>
          <c:dLbls>
            <c:dLbl>
              <c:idx val="3"/>
              <c:layout>
                <c:manualLayout>
                  <c:x val="-0.0840787192738369"/>
                  <c:y val="0.0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41308521538615101"/>
                      <c:h val="0.16137293931640978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E297-4119-B69E-AA7F820D2378}"/>
                </c:ext>
              </c:extLst>
            </c:dLbl>
            <c:dLbl>
              <c:idx val="14"/>
              <c:layout>
                <c:manualLayout>
                  <c:x val="-0.274872990717221"/>
                  <c:y val="-0.0419368345416865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35671529753986986"/>
                      <c:h val="0.20051398488865055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E297-4119-B69E-AA7F820D2378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Z$4:$Z$18</c:f>
              <c:numCache>
                <c:formatCode>General</c:formatCode>
                <c:ptCount val="15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5">
                  <c:v>1.5</c:v>
                </c:pt>
                <c:pt idx="6">
                  <c:v>1.5</c:v>
                </c:pt>
                <c:pt idx="7">
                  <c:v>1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  <c:pt idx="12">
                  <c:v>1.5</c:v>
                </c:pt>
                <c:pt idx="13">
                  <c:v>1.5</c:v>
                </c:pt>
                <c:pt idx="14">
                  <c:v>1.5</c:v>
                </c:pt>
              </c:numCache>
            </c:numRef>
          </c:xVal>
          <c:yVal>
            <c:numRef>
              <c:f>まとめ!$Y$4:$Y$18</c:f>
              <c:numCache>
                <c:formatCode>General</c:formatCode>
                <c:ptCount val="15"/>
                <c:pt idx="0">
                  <c:v>6.648005E6</c:v>
                </c:pt>
                <c:pt idx="1">
                  <c:v>289396.8</c:v>
                </c:pt>
                <c:pt idx="2">
                  <c:v>15511.08</c:v>
                </c:pt>
                <c:pt idx="3" formatCode="0.00E+00">
                  <c:v>2.31763762666667E6</c:v>
                </c:pt>
                <c:pt idx="5">
                  <c:v>4.832576E7</c:v>
                </c:pt>
                <c:pt idx="6">
                  <c:v>1.465464E7</c:v>
                </c:pt>
                <c:pt idx="7">
                  <c:v>1.54376E7</c:v>
                </c:pt>
                <c:pt idx="8">
                  <c:v>8.415414E6</c:v>
                </c:pt>
                <c:pt idx="9">
                  <c:v>5.087524E6</c:v>
                </c:pt>
                <c:pt idx="10">
                  <c:v>6.303015E6</c:v>
                </c:pt>
                <c:pt idx="11">
                  <c:v>202289.9999999999</c:v>
                </c:pt>
                <c:pt idx="12">
                  <c:v>1.024437E7</c:v>
                </c:pt>
                <c:pt idx="13">
                  <c:v>5.24094E6</c:v>
                </c:pt>
                <c:pt idx="14" formatCode="0.00E+00">
                  <c:v>1.26568392222222E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297-4119-B69E-AA7F820D23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61539480"/>
        <c:axId val="-2119126952"/>
      </c:scatterChart>
      <c:valAx>
        <c:axId val="-2061539480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crossAx val="-2119126952"/>
        <c:crosses val="autoZero"/>
        <c:crossBetween val="midCat"/>
        <c:majorUnit val="0.5"/>
      </c:valAx>
      <c:valAx>
        <c:axId val="-211912695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crossAx val="-2061539480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9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6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8923-4A1C-99D2-8A7A2CE4C493}"/>
              </c:ext>
            </c:extLst>
          </c:dPt>
          <c:dPt>
            <c:idx val="11"/>
            <c:marker>
              <c:symbol val="dash"/>
              <c:size val="18"/>
            </c:marker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8923-4A1C-99D2-8A7A2CE4C493}"/>
              </c:ext>
            </c:extLst>
          </c:dPt>
          <c:dLbls>
            <c:dLbl>
              <c:idx val="6"/>
              <c:layout>
                <c:manualLayout>
                  <c:x val="-0.094776119402985"/>
                  <c:y val="-0.0447326235111323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31249792703150919"/>
                      <c:h val="0.17255609519419285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0-8923-4A1C-99D2-8A7A2CE4C493}"/>
                </c:ext>
              </c:extLst>
            </c:dLbl>
            <c:dLbl>
              <c:idx val="11"/>
              <c:layout>
                <c:manualLayout>
                  <c:x val="-0.0421225124378111"/>
                  <c:y val="-0.0838736690833731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11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>
                    <c:manualLayout>
                      <c:w val="0.28617122719734656"/>
                      <c:h val="0.17814767313308441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1-8923-4A1C-99D2-8A7A2CE4C49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まとめ!$AI$4:$AI$15</c:f>
              <c:numCache>
                <c:formatCode>General</c:formatCode>
                <c:ptCount val="12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  <c:pt idx="8">
                  <c:v>1.5</c:v>
                </c:pt>
                <c:pt idx="9">
                  <c:v>1.5</c:v>
                </c:pt>
                <c:pt idx="10">
                  <c:v>1.5</c:v>
                </c:pt>
                <c:pt idx="11">
                  <c:v>1.5</c:v>
                </c:pt>
              </c:numCache>
            </c:numRef>
          </c:xVal>
          <c:yVal>
            <c:numRef>
              <c:f>まとめ!$AH$4:$AH$15</c:f>
              <c:numCache>
                <c:formatCode>General</c:formatCode>
                <c:ptCount val="12"/>
                <c:pt idx="0">
                  <c:v>1.7876313E6</c:v>
                </c:pt>
                <c:pt idx="1">
                  <c:v>3.1404564E6</c:v>
                </c:pt>
                <c:pt idx="2">
                  <c:v>868695.2000000002</c:v>
                </c:pt>
                <c:pt idx="3">
                  <c:v>1.579734E7</c:v>
                </c:pt>
                <c:pt idx="4">
                  <c:v>90213.90000000001</c:v>
                </c:pt>
                <c:pt idx="5">
                  <c:v>164579.9999999999</c:v>
                </c:pt>
                <c:pt idx="6" formatCode="0.00E+00">
                  <c:v>3.64148613333333E6</c:v>
                </c:pt>
                <c:pt idx="8">
                  <c:v>4.595492E6</c:v>
                </c:pt>
                <c:pt idx="9">
                  <c:v>9.673364E6</c:v>
                </c:pt>
                <c:pt idx="10">
                  <c:v>9.235716E6</c:v>
                </c:pt>
                <c:pt idx="11" formatCode="0.00E+00">
                  <c:v>7.83485733333333E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923-4A1C-99D2-8A7A2CE4C4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43659928"/>
        <c:axId val="-2118466664"/>
      </c:scatterChart>
      <c:valAx>
        <c:axId val="2143659928"/>
        <c:scaling>
          <c:orientation val="minMax"/>
          <c:max val="2.0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-2118466664"/>
        <c:crosses val="autoZero"/>
        <c:crossBetween val="midCat"/>
      </c:valAx>
      <c:valAx>
        <c:axId val="-2118466664"/>
        <c:scaling>
          <c:orientation val="minMax"/>
          <c:max val="6.0E7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E+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143659928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+mn-lt"/>
        </a:defRPr>
      </a:pPr>
      <a:endParaRPr lang="ja-JP"/>
    </a:p>
  </c:tx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8427</cdr:x>
      <cdr:y>0.10491</cdr:y>
    </cdr:from>
    <cdr:to>
      <cdr:x>0.71349</cdr:x>
      <cdr:y>0.78407</cdr:y>
    </cdr:to>
    <cdr:sp macro="" textlink="">
      <cdr:nvSpPr>
        <cdr:cNvPr id="2" name="フリーフォーム: 図形 1"/>
        <cdr:cNvSpPr/>
      </cdr:nvSpPr>
      <cdr:spPr>
        <a:xfrm xmlns:a="http://schemas.openxmlformats.org/drawingml/2006/main">
          <a:off x="558193" y="238283"/>
          <a:ext cx="842838" cy="1542553"/>
        </a:xfrm>
        <a:custGeom xmlns:a="http://schemas.openxmlformats.org/drawingml/2006/main">
          <a:avLst/>
          <a:gdLst>
            <a:gd name="connsiteX0" fmla="*/ 0 w 842838"/>
            <a:gd name="connsiteY0" fmla="*/ 1542553 h 1542553"/>
            <a:gd name="connsiteX1" fmla="*/ 7952 w 842838"/>
            <a:gd name="connsiteY1" fmla="*/ 0 h 1542553"/>
            <a:gd name="connsiteX2" fmla="*/ 842838 w 842838"/>
            <a:gd name="connsiteY2" fmla="*/ 0 h 1542553"/>
            <a:gd name="connsiteX3" fmla="*/ 842838 w 842838"/>
            <a:gd name="connsiteY3" fmla="*/ 190831 h 1542553"/>
          </a:gdLst>
          <a:ahLst/>
          <a:cxnLst>
            <a:cxn ang="0">
              <a:pos x="connsiteX0" y="connsiteY0"/>
            </a:cxn>
            <a:cxn ang="0">
              <a:pos x="connsiteX1" y="connsiteY1"/>
            </a:cxn>
            <a:cxn ang="0">
              <a:pos x="connsiteX2" y="connsiteY2"/>
            </a:cxn>
            <a:cxn ang="0">
              <a:pos x="connsiteX3" y="connsiteY3"/>
            </a:cxn>
          </a:cxnLst>
          <a:rect l="l" t="t" r="r" b="b"/>
          <a:pathLst>
            <a:path w="842838" h="1542553">
              <a:moveTo>
                <a:pt x="0" y="1542553"/>
              </a:moveTo>
              <a:cubicBezTo>
                <a:pt x="2651" y="1028369"/>
                <a:pt x="5301" y="514184"/>
                <a:pt x="7952" y="0"/>
              </a:cubicBezTo>
              <a:lnTo>
                <a:pt x="842838" y="0"/>
              </a:lnTo>
              <a:lnTo>
                <a:pt x="842838" y="190831"/>
              </a:lnTo>
            </a:path>
          </a:pathLst>
        </a:custGeom>
        <a:noFill xmlns:a="http://schemas.openxmlformats.org/drawingml/2006/main"/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ja-JP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B996BF-FAD8-4844-98BC-FC1F91D9FC8A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C906F-1E0F-0E4B-96A7-99B0A5C253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490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E9BEE5-49EE-42FF-8F0D-D34D1D5C74A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7832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2444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75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3341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859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5924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66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2649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7273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3990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553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2756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A5CDF-85B3-5E45-BDBD-85D4A6BDE5F8}" type="datetimeFigureOut">
              <a:rPr kumimoji="1" lang="ja-JP" altLang="en-US" smtClean="0"/>
              <a:t>2017/05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6620AD-A575-7F4F-9389-4AC39B2852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830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9" Type="http://schemas.openxmlformats.org/officeDocument/2006/relationships/chart" Target="../charts/chart7.xml"/><Relationship Id="rId10" Type="http://schemas.openxmlformats.org/officeDocument/2006/relationships/chart" Target="../charts/chart8.xml"/><Relationship Id="rId11" Type="http://schemas.openxmlformats.org/officeDocument/2006/relationships/chart" Target="../charts/chart9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テキスト ボックス 68"/>
          <p:cNvSpPr txBox="1"/>
          <p:nvPr/>
        </p:nvSpPr>
        <p:spPr>
          <a:xfrm>
            <a:off x="1" y="-86118"/>
            <a:ext cx="10527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Fig. S 5</a:t>
            </a:r>
            <a:endParaRPr kumimoji="1" lang="ja-JP" altLang="en-US" dirty="0"/>
          </a:p>
        </p:txBody>
      </p:sp>
      <p:grpSp>
        <p:nvGrpSpPr>
          <p:cNvPr id="194" name="図形グループ 193"/>
          <p:cNvGrpSpPr/>
          <p:nvPr/>
        </p:nvGrpSpPr>
        <p:grpSpPr>
          <a:xfrm>
            <a:off x="218110" y="168644"/>
            <a:ext cx="6361244" cy="9002789"/>
            <a:chOff x="218110" y="454358"/>
            <a:chExt cx="6522658" cy="9289723"/>
          </a:xfrm>
        </p:grpSpPr>
        <p:graphicFrame>
          <p:nvGraphicFramePr>
            <p:cNvPr id="195" name="グラフ 194">
              <a:extLst>
                <a:ext uri="{FF2B5EF4-FFF2-40B4-BE49-F238E27FC236}">
                  <a16:creationId xmlns:a16="http://schemas.microsoft.com/office/drawing/2014/main" xmlns="" id="{8225A982-25C8-47E5-9B00-0622C9CEAE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18731514"/>
                </p:ext>
              </p:extLst>
            </p:nvPr>
          </p:nvGraphicFramePr>
          <p:xfrm>
            <a:off x="3005296" y="900430"/>
            <a:ext cx="1963636" cy="22708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96" name="グラフ 195">
              <a:extLst>
                <a:ext uri="{FF2B5EF4-FFF2-40B4-BE49-F238E27FC236}">
                  <a16:creationId xmlns:a16="http://schemas.microsoft.com/office/drawing/2014/main" xmlns="" id="{547485DB-DCAE-4D74-8D63-8A5733176C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19068880"/>
                </p:ext>
              </p:extLst>
            </p:nvPr>
          </p:nvGraphicFramePr>
          <p:xfrm>
            <a:off x="4777132" y="900431"/>
            <a:ext cx="1963636" cy="22708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197" name="グラフ 196">
              <a:extLst>
                <a:ext uri="{FF2B5EF4-FFF2-40B4-BE49-F238E27FC236}">
                  <a16:creationId xmlns:a16="http://schemas.microsoft.com/office/drawing/2014/main" xmlns="" id="{E4C77BB3-4C64-4302-B16E-60C5AB6A8A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7012690"/>
                </p:ext>
              </p:extLst>
            </p:nvPr>
          </p:nvGraphicFramePr>
          <p:xfrm>
            <a:off x="795753" y="900431"/>
            <a:ext cx="2376000" cy="227085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98" name="テキスト ボックス 197"/>
            <p:cNvSpPr txBox="1"/>
            <p:nvPr/>
          </p:nvSpPr>
          <p:spPr>
            <a:xfrm>
              <a:off x="357294" y="454358"/>
              <a:ext cx="267592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/>
                <a:t>(A) Spleen cell count</a:t>
              </a:r>
              <a:endParaRPr kumimoji="1" lang="ja-JP" altLang="en-US" sz="2000" b="1" dirty="0"/>
            </a:p>
          </p:txBody>
        </p:sp>
        <p:graphicFrame>
          <p:nvGraphicFramePr>
            <p:cNvPr id="199" name="グラフ 198">
              <a:extLst>
                <a:ext uri="{FF2B5EF4-FFF2-40B4-BE49-F238E27FC236}">
                  <a16:creationId xmlns:a16="http://schemas.microsoft.com/office/drawing/2014/main" xmlns="" id="{8225A982-25C8-47E5-9B00-0622C9CEAE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9823290"/>
                </p:ext>
              </p:extLst>
            </p:nvPr>
          </p:nvGraphicFramePr>
          <p:xfrm>
            <a:off x="3005296" y="4017229"/>
            <a:ext cx="1963636" cy="2271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200" name="グラフ 199">
              <a:extLst>
                <a:ext uri="{FF2B5EF4-FFF2-40B4-BE49-F238E27FC236}">
                  <a16:creationId xmlns:a16="http://schemas.microsoft.com/office/drawing/2014/main" xmlns="" id="{547485DB-DCAE-4D74-8D63-8A5733176C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69796296"/>
                </p:ext>
              </p:extLst>
            </p:nvPr>
          </p:nvGraphicFramePr>
          <p:xfrm>
            <a:off x="4777132" y="4017229"/>
            <a:ext cx="1963636" cy="2271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201" name="グラフ 200">
              <a:extLst>
                <a:ext uri="{FF2B5EF4-FFF2-40B4-BE49-F238E27FC236}">
                  <a16:creationId xmlns:a16="http://schemas.microsoft.com/office/drawing/2014/main" xmlns="" id="{E4C77BB3-4C64-4302-B16E-60C5AB6A8A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08347096"/>
                </p:ext>
              </p:extLst>
            </p:nvPr>
          </p:nvGraphicFramePr>
          <p:xfrm>
            <a:off x="1011753" y="4017229"/>
            <a:ext cx="2160000" cy="2271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02" name="テキスト ボックス 201"/>
            <p:cNvSpPr txBox="1"/>
            <p:nvPr/>
          </p:nvSpPr>
          <p:spPr>
            <a:xfrm>
              <a:off x="357294" y="3589719"/>
              <a:ext cx="554820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/>
                <a:t>(B) Plasma</a:t>
              </a:r>
              <a:r>
                <a:rPr kumimoji="1" lang="ja-JP" altLang="en-US" sz="2000" b="1" dirty="0"/>
                <a:t> </a:t>
              </a:r>
              <a:r>
                <a:rPr kumimoji="1" lang="en-US" altLang="ja-JP" sz="2000" b="1" dirty="0"/>
                <a:t>cell % of Lymphocyte + Monocyte Gate</a:t>
              </a:r>
              <a:endParaRPr kumimoji="1" lang="ja-JP" altLang="en-US" sz="2000" b="1" dirty="0"/>
            </a:p>
          </p:txBody>
        </p:sp>
        <p:graphicFrame>
          <p:nvGraphicFramePr>
            <p:cNvPr id="203" name="グラフ 202">
              <a:extLst>
                <a:ext uri="{FF2B5EF4-FFF2-40B4-BE49-F238E27FC236}">
                  <a16:creationId xmlns:a16="http://schemas.microsoft.com/office/drawing/2014/main" xmlns="" id="{8225A982-25C8-47E5-9B00-0622C9CEAE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828782"/>
                </p:ext>
              </p:extLst>
            </p:nvPr>
          </p:nvGraphicFramePr>
          <p:xfrm>
            <a:off x="3005296" y="7124625"/>
            <a:ext cx="1963636" cy="2271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204" name="グラフ 203">
              <a:extLst>
                <a:ext uri="{FF2B5EF4-FFF2-40B4-BE49-F238E27FC236}">
                  <a16:creationId xmlns:a16="http://schemas.microsoft.com/office/drawing/2014/main" xmlns="" id="{547485DB-DCAE-4D74-8D63-8A5733176C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91259068"/>
                </p:ext>
              </p:extLst>
            </p:nvPr>
          </p:nvGraphicFramePr>
          <p:xfrm>
            <a:off x="4777132" y="7124625"/>
            <a:ext cx="1963636" cy="2271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205" name="グラフ 204">
              <a:extLst>
                <a:ext uri="{FF2B5EF4-FFF2-40B4-BE49-F238E27FC236}">
                  <a16:creationId xmlns:a16="http://schemas.microsoft.com/office/drawing/2014/main" xmlns="" id="{E4C77BB3-4C64-4302-B16E-60C5AB6A8A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1117607"/>
                </p:ext>
              </p:extLst>
            </p:nvPr>
          </p:nvGraphicFramePr>
          <p:xfrm>
            <a:off x="759753" y="7124625"/>
            <a:ext cx="2412000" cy="227127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206" name="テキスト ボックス 205"/>
            <p:cNvSpPr txBox="1"/>
            <p:nvPr/>
          </p:nvSpPr>
          <p:spPr>
            <a:xfrm>
              <a:off x="357295" y="6709032"/>
              <a:ext cx="26798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b="1" dirty="0"/>
                <a:t>(C) Plasma</a:t>
              </a:r>
              <a:r>
                <a:rPr kumimoji="1" lang="ja-JP" altLang="en-US" sz="2000" b="1" dirty="0"/>
                <a:t> </a:t>
              </a:r>
              <a:r>
                <a:rPr kumimoji="1" lang="en-US" altLang="ja-JP" sz="2000" b="1" dirty="0"/>
                <a:t>cell Count</a:t>
              </a:r>
              <a:endParaRPr kumimoji="1" lang="ja-JP" altLang="en-US" sz="2000" b="1" dirty="0"/>
            </a:p>
          </p:txBody>
        </p:sp>
        <p:sp>
          <p:nvSpPr>
            <p:cNvPr id="207" name="テキスト ボックス 206"/>
            <p:cNvSpPr txBox="1"/>
            <p:nvPr/>
          </p:nvSpPr>
          <p:spPr>
            <a:xfrm rot="16200000">
              <a:off x="-535649" y="4952592"/>
              <a:ext cx="1946300" cy="438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Plasma cells % of</a:t>
              </a:r>
            </a:p>
            <a:p>
              <a:r>
                <a:rPr kumimoji="1" lang="en-US" altLang="ja-JP" sz="1100" dirty="0"/>
                <a:t>Lymphocyte + Monocyte Gate</a:t>
              </a:r>
              <a:endParaRPr kumimoji="1" lang="ja-JP" altLang="en-US" sz="1100" dirty="0"/>
            </a:p>
          </p:txBody>
        </p:sp>
        <p:cxnSp>
          <p:nvCxnSpPr>
            <p:cNvPr id="208" name="直線矢印コネクタ 207"/>
            <p:cNvCxnSpPr>
              <a:cxnSpLocks/>
            </p:cNvCxnSpPr>
            <p:nvPr/>
          </p:nvCxnSpPr>
          <p:spPr>
            <a:xfrm flipV="1">
              <a:off x="656890" y="4198833"/>
              <a:ext cx="0" cy="1946302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9" name="テキスト ボックス 208"/>
            <p:cNvSpPr txBox="1"/>
            <p:nvPr/>
          </p:nvSpPr>
          <p:spPr>
            <a:xfrm rot="16200000">
              <a:off x="-447063" y="1982806"/>
              <a:ext cx="1946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Spleen cells count</a:t>
              </a:r>
            </a:p>
          </p:txBody>
        </p:sp>
        <p:cxnSp>
          <p:nvCxnSpPr>
            <p:cNvPr id="210" name="直線矢印コネクタ 209"/>
            <p:cNvCxnSpPr>
              <a:cxnSpLocks/>
            </p:cNvCxnSpPr>
            <p:nvPr/>
          </p:nvCxnSpPr>
          <p:spPr>
            <a:xfrm flipV="1">
              <a:off x="656890" y="1140462"/>
              <a:ext cx="0" cy="1946302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テキスト ボックス 210"/>
            <p:cNvSpPr txBox="1"/>
            <p:nvPr/>
          </p:nvSpPr>
          <p:spPr>
            <a:xfrm rot="16200000">
              <a:off x="-447063" y="8231206"/>
              <a:ext cx="19463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100" dirty="0"/>
                <a:t>Plasma cells count</a:t>
              </a:r>
            </a:p>
          </p:txBody>
        </p:sp>
        <p:cxnSp>
          <p:nvCxnSpPr>
            <p:cNvPr id="212" name="直線矢印コネクタ 211"/>
            <p:cNvCxnSpPr>
              <a:cxnSpLocks/>
            </p:cNvCxnSpPr>
            <p:nvPr/>
          </p:nvCxnSpPr>
          <p:spPr>
            <a:xfrm flipV="1">
              <a:off x="656890" y="7388862"/>
              <a:ext cx="0" cy="1946302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テキスト ボックス 212"/>
            <p:cNvSpPr txBox="1"/>
            <p:nvPr/>
          </p:nvSpPr>
          <p:spPr>
            <a:xfrm>
              <a:off x="1278515" y="741292"/>
              <a:ext cx="16573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No stimulation</a:t>
              </a:r>
              <a:endParaRPr kumimoji="1" lang="ja-JP" altLang="en-US" sz="1600" b="1" dirty="0"/>
            </a:p>
          </p:txBody>
        </p:sp>
        <p:sp>
          <p:nvSpPr>
            <p:cNvPr id="214" name="テキスト ボックス 213"/>
            <p:cNvSpPr txBox="1"/>
            <p:nvPr/>
          </p:nvSpPr>
          <p:spPr>
            <a:xfrm>
              <a:off x="3112565" y="741292"/>
              <a:ext cx="61212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PBS</a:t>
              </a:r>
              <a:endParaRPr kumimoji="1" lang="ja-JP" altLang="en-US" sz="1600" b="1" dirty="0"/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4896162" y="741292"/>
              <a:ext cx="11979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CH401MAP</a:t>
              </a:r>
              <a:endParaRPr kumimoji="1" lang="ja-JP" altLang="en-US" sz="1600" b="1" dirty="0"/>
            </a:p>
          </p:txBody>
        </p:sp>
        <p:sp>
          <p:nvSpPr>
            <p:cNvPr id="216" name="テキスト ボックス 215"/>
            <p:cNvSpPr txBox="1"/>
            <p:nvPr/>
          </p:nvSpPr>
          <p:spPr>
            <a:xfrm>
              <a:off x="1278515" y="3884542"/>
              <a:ext cx="16573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No stimulation</a:t>
              </a:r>
              <a:endParaRPr kumimoji="1" lang="ja-JP" altLang="en-US" sz="1600" b="1" dirty="0"/>
            </a:p>
          </p:txBody>
        </p:sp>
        <p:sp>
          <p:nvSpPr>
            <p:cNvPr id="217" name="テキスト ボックス 216"/>
            <p:cNvSpPr txBox="1"/>
            <p:nvPr/>
          </p:nvSpPr>
          <p:spPr>
            <a:xfrm>
              <a:off x="3112565" y="3884542"/>
              <a:ext cx="61212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PBS</a:t>
              </a:r>
              <a:endParaRPr kumimoji="1" lang="ja-JP" altLang="en-US" sz="1600" b="1" dirty="0"/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>
              <a:off x="4896162" y="3884542"/>
              <a:ext cx="11979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CH401MAP</a:t>
              </a:r>
              <a:endParaRPr kumimoji="1" lang="ja-JP" altLang="en-US" sz="1600" b="1" dirty="0"/>
            </a:p>
          </p:txBody>
        </p:sp>
        <p:sp>
          <p:nvSpPr>
            <p:cNvPr id="219" name="テキスト ボックス 218"/>
            <p:cNvSpPr txBox="1"/>
            <p:nvPr/>
          </p:nvSpPr>
          <p:spPr>
            <a:xfrm>
              <a:off x="1278515" y="6989692"/>
              <a:ext cx="165735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No stimulation</a:t>
              </a:r>
              <a:endParaRPr kumimoji="1" lang="ja-JP" altLang="en-US" sz="1600" b="1" dirty="0"/>
            </a:p>
          </p:txBody>
        </p:sp>
        <p:sp>
          <p:nvSpPr>
            <p:cNvPr id="220" name="テキスト ボックス 219"/>
            <p:cNvSpPr txBox="1"/>
            <p:nvPr/>
          </p:nvSpPr>
          <p:spPr>
            <a:xfrm>
              <a:off x="3112565" y="6989692"/>
              <a:ext cx="61212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PBS</a:t>
              </a:r>
              <a:endParaRPr kumimoji="1" lang="ja-JP" altLang="en-US" sz="1600" b="1" dirty="0"/>
            </a:p>
          </p:txBody>
        </p:sp>
        <p:sp>
          <p:nvSpPr>
            <p:cNvPr id="221" name="テキスト ボックス 220"/>
            <p:cNvSpPr txBox="1"/>
            <p:nvPr/>
          </p:nvSpPr>
          <p:spPr>
            <a:xfrm>
              <a:off x="4896162" y="6989692"/>
              <a:ext cx="11979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/>
                <a:t>CH401MAP</a:t>
              </a:r>
              <a:endParaRPr kumimoji="1" lang="ja-JP" altLang="en-US" sz="1600" b="1" dirty="0"/>
            </a:p>
          </p:txBody>
        </p:sp>
        <p:sp>
          <p:nvSpPr>
            <p:cNvPr id="222" name="テキスト ボックス 221"/>
            <p:cNvSpPr txBox="1"/>
            <p:nvPr/>
          </p:nvSpPr>
          <p:spPr>
            <a:xfrm>
              <a:off x="1455905" y="2980943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23" name="テキスト ボックス 222"/>
            <p:cNvSpPr txBox="1"/>
            <p:nvPr/>
          </p:nvSpPr>
          <p:spPr>
            <a:xfrm>
              <a:off x="2195671" y="2980943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24" name="テキスト ボックス 223"/>
            <p:cNvSpPr txBox="1"/>
            <p:nvPr/>
          </p:nvSpPr>
          <p:spPr>
            <a:xfrm>
              <a:off x="3251094" y="2980943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25" name="テキスト ボックス 224"/>
            <p:cNvSpPr txBox="1"/>
            <p:nvPr/>
          </p:nvSpPr>
          <p:spPr>
            <a:xfrm>
              <a:off x="3990860" y="2980943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26" name="テキスト ボックス 225"/>
            <p:cNvSpPr txBox="1"/>
            <p:nvPr/>
          </p:nvSpPr>
          <p:spPr>
            <a:xfrm>
              <a:off x="5023901" y="2980943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27" name="テキスト ボックス 226"/>
            <p:cNvSpPr txBox="1"/>
            <p:nvPr/>
          </p:nvSpPr>
          <p:spPr>
            <a:xfrm>
              <a:off x="5763667" y="2980943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28" name="テキスト ボックス 227"/>
            <p:cNvSpPr txBox="1"/>
            <p:nvPr/>
          </p:nvSpPr>
          <p:spPr>
            <a:xfrm>
              <a:off x="1430086" y="6086139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29" name="テキスト ボックス 228"/>
            <p:cNvSpPr txBox="1"/>
            <p:nvPr/>
          </p:nvSpPr>
          <p:spPr>
            <a:xfrm>
              <a:off x="2169852" y="6086139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30" name="テキスト ボックス 229"/>
            <p:cNvSpPr txBox="1"/>
            <p:nvPr/>
          </p:nvSpPr>
          <p:spPr>
            <a:xfrm>
              <a:off x="3225275" y="6086139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31" name="テキスト ボックス 230"/>
            <p:cNvSpPr txBox="1"/>
            <p:nvPr/>
          </p:nvSpPr>
          <p:spPr>
            <a:xfrm>
              <a:off x="3965041" y="6086139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32" name="テキスト ボックス 231"/>
            <p:cNvSpPr txBox="1"/>
            <p:nvPr/>
          </p:nvSpPr>
          <p:spPr>
            <a:xfrm>
              <a:off x="4998082" y="6086139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33" name="テキスト ボックス 232"/>
            <p:cNvSpPr txBox="1"/>
            <p:nvPr/>
          </p:nvSpPr>
          <p:spPr>
            <a:xfrm>
              <a:off x="5737848" y="6086139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34" name="テキスト ボックス 233"/>
            <p:cNvSpPr txBox="1"/>
            <p:nvPr/>
          </p:nvSpPr>
          <p:spPr>
            <a:xfrm>
              <a:off x="1431317" y="9220861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35" name="テキスト ボックス 234"/>
            <p:cNvSpPr txBox="1"/>
            <p:nvPr/>
          </p:nvSpPr>
          <p:spPr>
            <a:xfrm>
              <a:off x="2171083" y="9220861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36" name="テキスト ボックス 235"/>
            <p:cNvSpPr txBox="1"/>
            <p:nvPr/>
          </p:nvSpPr>
          <p:spPr>
            <a:xfrm>
              <a:off x="3226506" y="9220861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37" name="テキスト ボックス 236"/>
            <p:cNvSpPr txBox="1"/>
            <p:nvPr/>
          </p:nvSpPr>
          <p:spPr>
            <a:xfrm>
              <a:off x="3966272" y="9220861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38" name="テキスト ボックス 237"/>
            <p:cNvSpPr txBox="1"/>
            <p:nvPr/>
          </p:nvSpPr>
          <p:spPr>
            <a:xfrm>
              <a:off x="4999313" y="9220861"/>
              <a:ext cx="6322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  <a:endParaRPr kumimoji="1" lang="ja-JP" altLang="en-US" sz="1400" dirty="0"/>
            </a:p>
          </p:txBody>
        </p:sp>
        <p:sp>
          <p:nvSpPr>
            <p:cNvPr id="239" name="テキスト ボックス 238"/>
            <p:cNvSpPr txBox="1"/>
            <p:nvPr/>
          </p:nvSpPr>
          <p:spPr>
            <a:xfrm>
              <a:off x="5739079" y="9220861"/>
              <a:ext cx="841506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/>
                <a:t>NOG</a:t>
              </a:r>
            </a:p>
            <a:p>
              <a:pPr algn="ctr"/>
              <a:r>
                <a:rPr kumimoji="1" lang="en-US" altLang="ja-JP" sz="1400" dirty="0"/>
                <a:t>IL-4-Tg</a:t>
              </a:r>
              <a:endParaRPr kumimoji="1" lang="ja-JP" altLang="en-US" sz="1400" dirty="0"/>
            </a:p>
          </p:txBody>
        </p:sp>
        <p:sp>
          <p:nvSpPr>
            <p:cNvPr id="240" name="正方形/長方形 239"/>
            <p:cNvSpPr/>
            <p:nvPr/>
          </p:nvSpPr>
          <p:spPr>
            <a:xfrm>
              <a:off x="3761470" y="1154918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53</a:t>
              </a:r>
            </a:p>
          </p:txBody>
        </p:sp>
        <p:sp>
          <p:nvSpPr>
            <p:cNvPr id="241" name="正方形/長方形 240"/>
            <p:cNvSpPr/>
            <p:nvPr/>
          </p:nvSpPr>
          <p:spPr>
            <a:xfrm>
              <a:off x="3755109" y="4213966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ja-JP" sz="1200" dirty="0"/>
                <a:t>0.21</a:t>
              </a:r>
            </a:p>
          </p:txBody>
        </p:sp>
        <p:sp>
          <p:nvSpPr>
            <p:cNvPr id="242" name="正方形/長方形 241"/>
            <p:cNvSpPr/>
            <p:nvPr/>
          </p:nvSpPr>
          <p:spPr>
            <a:xfrm>
              <a:off x="3761470" y="7699035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20</a:t>
              </a:r>
            </a:p>
          </p:txBody>
        </p:sp>
        <p:sp>
          <p:nvSpPr>
            <p:cNvPr id="243" name="正方形/長方形 242"/>
            <p:cNvSpPr/>
            <p:nvPr/>
          </p:nvSpPr>
          <p:spPr>
            <a:xfrm>
              <a:off x="5535033" y="1152308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08</a:t>
              </a:r>
            </a:p>
          </p:txBody>
        </p:sp>
        <p:sp>
          <p:nvSpPr>
            <p:cNvPr id="244" name="正方形/長方形 243"/>
            <p:cNvSpPr/>
            <p:nvPr/>
          </p:nvSpPr>
          <p:spPr>
            <a:xfrm>
              <a:off x="5500463" y="4196509"/>
              <a:ext cx="5373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042</a:t>
              </a:r>
            </a:p>
          </p:txBody>
        </p:sp>
        <p:sp>
          <p:nvSpPr>
            <p:cNvPr id="245" name="正方形/長方形 244"/>
            <p:cNvSpPr/>
            <p:nvPr/>
          </p:nvSpPr>
          <p:spPr>
            <a:xfrm>
              <a:off x="5557414" y="7324679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08</a:t>
              </a:r>
            </a:p>
          </p:txBody>
        </p:sp>
        <p:sp>
          <p:nvSpPr>
            <p:cNvPr id="246" name="正方形/長方形 245"/>
            <p:cNvSpPr/>
            <p:nvPr/>
          </p:nvSpPr>
          <p:spPr>
            <a:xfrm>
              <a:off x="1924261" y="1099414"/>
              <a:ext cx="53732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012</a:t>
              </a:r>
            </a:p>
          </p:txBody>
        </p:sp>
        <p:sp>
          <p:nvSpPr>
            <p:cNvPr id="247" name="正方形/長方形 246"/>
            <p:cNvSpPr/>
            <p:nvPr/>
          </p:nvSpPr>
          <p:spPr>
            <a:xfrm>
              <a:off x="1958034" y="4685080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61</a:t>
              </a:r>
            </a:p>
          </p:txBody>
        </p:sp>
        <p:sp>
          <p:nvSpPr>
            <p:cNvPr id="248" name="正方形/長方形 247"/>
            <p:cNvSpPr/>
            <p:nvPr/>
          </p:nvSpPr>
          <p:spPr>
            <a:xfrm>
              <a:off x="1958034" y="7699036"/>
              <a:ext cx="45878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dirty="0"/>
                <a:t>0.17</a:t>
              </a:r>
            </a:p>
          </p:txBody>
        </p:sp>
        <p:sp>
          <p:nvSpPr>
            <p:cNvPr id="249" name="フリーフォーム: 図形 60"/>
            <p:cNvSpPr/>
            <p:nvPr/>
          </p:nvSpPr>
          <p:spPr>
            <a:xfrm>
              <a:off x="1769806" y="1135626"/>
              <a:ext cx="848033" cy="1165122"/>
            </a:xfrm>
            <a:custGeom>
              <a:avLst/>
              <a:gdLst>
                <a:gd name="connsiteX0" fmla="*/ 0 w 848033"/>
                <a:gd name="connsiteY0" fmla="*/ 1165122 h 1165122"/>
                <a:gd name="connsiteX1" fmla="*/ 0 w 848033"/>
                <a:gd name="connsiteY1" fmla="*/ 0 h 1165122"/>
                <a:gd name="connsiteX2" fmla="*/ 848033 w 848033"/>
                <a:gd name="connsiteY2" fmla="*/ 0 h 1165122"/>
                <a:gd name="connsiteX3" fmla="*/ 848033 w 848033"/>
                <a:gd name="connsiteY3" fmla="*/ 169606 h 116512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48033" h="1165122">
                  <a:moveTo>
                    <a:pt x="0" y="1165122"/>
                  </a:moveTo>
                  <a:lnTo>
                    <a:pt x="0" y="0"/>
                  </a:lnTo>
                  <a:lnTo>
                    <a:pt x="848033" y="0"/>
                  </a:lnTo>
                  <a:lnTo>
                    <a:pt x="848033" y="169606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0" name="フリーフォーム: 図形 61"/>
            <p:cNvSpPr/>
            <p:nvPr/>
          </p:nvSpPr>
          <p:spPr>
            <a:xfrm>
              <a:off x="3561735" y="1378974"/>
              <a:ext cx="840659" cy="1091381"/>
            </a:xfrm>
            <a:custGeom>
              <a:avLst/>
              <a:gdLst>
                <a:gd name="connsiteX0" fmla="*/ 0 w 840659"/>
                <a:gd name="connsiteY0" fmla="*/ 1091381 h 1091381"/>
                <a:gd name="connsiteX1" fmla="*/ 0 w 840659"/>
                <a:gd name="connsiteY1" fmla="*/ 0 h 1091381"/>
                <a:gd name="connsiteX2" fmla="*/ 840659 w 840659"/>
                <a:gd name="connsiteY2" fmla="*/ 0 h 1091381"/>
                <a:gd name="connsiteX3" fmla="*/ 840659 w 840659"/>
                <a:gd name="connsiteY3" fmla="*/ 619432 h 10913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40659" h="1091381">
                  <a:moveTo>
                    <a:pt x="0" y="1091381"/>
                  </a:moveTo>
                  <a:lnTo>
                    <a:pt x="0" y="0"/>
                  </a:lnTo>
                  <a:lnTo>
                    <a:pt x="840659" y="0"/>
                  </a:lnTo>
                  <a:lnTo>
                    <a:pt x="840659" y="619432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1" name="フリーフォーム: 図形 62"/>
            <p:cNvSpPr/>
            <p:nvPr/>
          </p:nvSpPr>
          <p:spPr>
            <a:xfrm>
              <a:off x="5331542" y="1371600"/>
              <a:ext cx="855406" cy="1238865"/>
            </a:xfrm>
            <a:custGeom>
              <a:avLst/>
              <a:gdLst>
                <a:gd name="connsiteX0" fmla="*/ 0 w 855406"/>
                <a:gd name="connsiteY0" fmla="*/ 1238865 h 1238865"/>
                <a:gd name="connsiteX1" fmla="*/ 7374 w 855406"/>
                <a:gd name="connsiteY1" fmla="*/ 0 h 1238865"/>
                <a:gd name="connsiteX2" fmla="*/ 855406 w 855406"/>
                <a:gd name="connsiteY2" fmla="*/ 0 h 1238865"/>
                <a:gd name="connsiteX3" fmla="*/ 848032 w 855406"/>
                <a:gd name="connsiteY3" fmla="*/ 803787 h 123886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55406" h="1238865">
                  <a:moveTo>
                    <a:pt x="0" y="1238865"/>
                  </a:moveTo>
                  <a:lnTo>
                    <a:pt x="7374" y="0"/>
                  </a:lnTo>
                  <a:lnTo>
                    <a:pt x="855406" y="0"/>
                  </a:lnTo>
                  <a:lnTo>
                    <a:pt x="848032" y="803787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2" name="フリーフォーム: 図形 63"/>
            <p:cNvSpPr/>
            <p:nvPr/>
          </p:nvSpPr>
          <p:spPr>
            <a:xfrm>
              <a:off x="1740310" y="4911213"/>
              <a:ext cx="870155" cy="973393"/>
            </a:xfrm>
            <a:custGeom>
              <a:avLst/>
              <a:gdLst>
                <a:gd name="connsiteX0" fmla="*/ 0 w 870155"/>
                <a:gd name="connsiteY0" fmla="*/ 516193 h 973393"/>
                <a:gd name="connsiteX1" fmla="*/ 0 w 870155"/>
                <a:gd name="connsiteY1" fmla="*/ 0 h 973393"/>
                <a:gd name="connsiteX2" fmla="*/ 870155 w 870155"/>
                <a:gd name="connsiteY2" fmla="*/ 0 h 973393"/>
                <a:gd name="connsiteX3" fmla="*/ 870155 w 870155"/>
                <a:gd name="connsiteY3" fmla="*/ 973393 h 9733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70155" h="973393">
                  <a:moveTo>
                    <a:pt x="0" y="516193"/>
                  </a:moveTo>
                  <a:lnTo>
                    <a:pt x="0" y="0"/>
                  </a:lnTo>
                  <a:lnTo>
                    <a:pt x="870155" y="0"/>
                  </a:lnTo>
                  <a:lnTo>
                    <a:pt x="870155" y="973393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3" name="フリーフォーム: 図形 64"/>
            <p:cNvSpPr/>
            <p:nvPr/>
          </p:nvSpPr>
          <p:spPr>
            <a:xfrm>
              <a:off x="3561735" y="4247535"/>
              <a:ext cx="848033" cy="1268362"/>
            </a:xfrm>
            <a:custGeom>
              <a:avLst/>
              <a:gdLst>
                <a:gd name="connsiteX0" fmla="*/ 0 w 848033"/>
                <a:gd name="connsiteY0" fmla="*/ 1268362 h 1268362"/>
                <a:gd name="connsiteX1" fmla="*/ 7375 w 848033"/>
                <a:gd name="connsiteY1" fmla="*/ 0 h 1268362"/>
                <a:gd name="connsiteX2" fmla="*/ 848033 w 848033"/>
                <a:gd name="connsiteY2" fmla="*/ 0 h 1268362"/>
                <a:gd name="connsiteX3" fmla="*/ 848033 w 848033"/>
                <a:gd name="connsiteY3" fmla="*/ 81117 h 126836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48033" h="1268362">
                  <a:moveTo>
                    <a:pt x="0" y="1268362"/>
                  </a:moveTo>
                  <a:cubicBezTo>
                    <a:pt x="2458" y="845575"/>
                    <a:pt x="4917" y="422787"/>
                    <a:pt x="7375" y="0"/>
                  </a:cubicBezTo>
                  <a:lnTo>
                    <a:pt x="848033" y="0"/>
                  </a:lnTo>
                  <a:lnTo>
                    <a:pt x="848033" y="81117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4" name="フリーフォーム: 図形 65"/>
            <p:cNvSpPr/>
            <p:nvPr/>
          </p:nvSpPr>
          <p:spPr>
            <a:xfrm>
              <a:off x="5338916" y="4409768"/>
              <a:ext cx="840658" cy="1260987"/>
            </a:xfrm>
            <a:custGeom>
              <a:avLst/>
              <a:gdLst>
                <a:gd name="connsiteX0" fmla="*/ 0 w 840658"/>
                <a:gd name="connsiteY0" fmla="*/ 1260987 h 1260987"/>
                <a:gd name="connsiteX1" fmla="*/ 0 w 840658"/>
                <a:gd name="connsiteY1" fmla="*/ 0 h 1260987"/>
                <a:gd name="connsiteX2" fmla="*/ 840658 w 840658"/>
                <a:gd name="connsiteY2" fmla="*/ 0 h 1260987"/>
                <a:gd name="connsiteX3" fmla="*/ 840658 w 840658"/>
                <a:gd name="connsiteY3" fmla="*/ 582561 h 12609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40658" h="1260987">
                  <a:moveTo>
                    <a:pt x="0" y="1260987"/>
                  </a:moveTo>
                  <a:lnTo>
                    <a:pt x="0" y="0"/>
                  </a:lnTo>
                  <a:lnTo>
                    <a:pt x="840658" y="0"/>
                  </a:lnTo>
                  <a:lnTo>
                    <a:pt x="840658" y="582561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5" name="フリーフォーム: 図形 66"/>
            <p:cNvSpPr/>
            <p:nvPr/>
          </p:nvSpPr>
          <p:spPr>
            <a:xfrm>
              <a:off x="1741336" y="7927450"/>
              <a:ext cx="858741" cy="787180"/>
            </a:xfrm>
            <a:custGeom>
              <a:avLst/>
              <a:gdLst>
                <a:gd name="connsiteX0" fmla="*/ 0 w 858741"/>
                <a:gd name="connsiteY0" fmla="*/ 675861 h 787180"/>
                <a:gd name="connsiteX1" fmla="*/ 0 w 858741"/>
                <a:gd name="connsiteY1" fmla="*/ 0 h 787180"/>
                <a:gd name="connsiteX2" fmla="*/ 858741 w 858741"/>
                <a:gd name="connsiteY2" fmla="*/ 7952 h 787180"/>
                <a:gd name="connsiteX3" fmla="*/ 858741 w 858741"/>
                <a:gd name="connsiteY3" fmla="*/ 787180 h 7871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58741" h="787180">
                  <a:moveTo>
                    <a:pt x="0" y="675861"/>
                  </a:moveTo>
                  <a:lnTo>
                    <a:pt x="0" y="0"/>
                  </a:lnTo>
                  <a:lnTo>
                    <a:pt x="858741" y="7952"/>
                  </a:lnTo>
                  <a:lnTo>
                    <a:pt x="858741" y="787180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6" name="フリーフォーム: 図形 67"/>
            <p:cNvSpPr/>
            <p:nvPr/>
          </p:nvSpPr>
          <p:spPr>
            <a:xfrm>
              <a:off x="3562184" y="7935402"/>
              <a:ext cx="842839" cy="985961"/>
            </a:xfrm>
            <a:custGeom>
              <a:avLst/>
              <a:gdLst>
                <a:gd name="connsiteX0" fmla="*/ 0 w 842839"/>
                <a:gd name="connsiteY0" fmla="*/ 985961 h 985961"/>
                <a:gd name="connsiteX1" fmla="*/ 7952 w 842839"/>
                <a:gd name="connsiteY1" fmla="*/ 0 h 985961"/>
                <a:gd name="connsiteX2" fmla="*/ 842839 w 842839"/>
                <a:gd name="connsiteY2" fmla="*/ 0 h 985961"/>
                <a:gd name="connsiteX3" fmla="*/ 842839 w 842839"/>
                <a:gd name="connsiteY3" fmla="*/ 413468 h 98596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842839" h="985961">
                  <a:moveTo>
                    <a:pt x="0" y="985961"/>
                  </a:moveTo>
                  <a:cubicBezTo>
                    <a:pt x="2651" y="657307"/>
                    <a:pt x="5301" y="328654"/>
                    <a:pt x="7952" y="0"/>
                  </a:cubicBezTo>
                  <a:lnTo>
                    <a:pt x="842839" y="0"/>
                  </a:lnTo>
                  <a:lnTo>
                    <a:pt x="842839" y="413468"/>
                  </a:ln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190368946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68</Words>
  <Application>Microsoft Macintosh PowerPoint</Application>
  <PresentationFormat>画面に合わせる (4:3)</PresentationFormat>
  <Paragraphs>7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metani Yoshie</dc:creator>
  <cp:lastModifiedBy>Kametani Yoshie</cp:lastModifiedBy>
  <cp:revision>11</cp:revision>
  <dcterms:created xsi:type="dcterms:W3CDTF">2017-04-22T05:45:50Z</dcterms:created>
  <dcterms:modified xsi:type="dcterms:W3CDTF">2017-05-09T11:21:16Z</dcterms:modified>
</cp:coreProperties>
</file>